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4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37095-8A23-40F2-A0BF-29455B5637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824A0-700B-4AD4-AB52-E2D1C9C043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9F933-FC3E-44ED-AFCF-7F8B7A861D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EFF72-A096-47A9-8CFC-896380DB51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646C5C-FFA9-42E4-B25F-349BF0D172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0AAF0-9CFC-4B24-B9F0-3E797813EC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5384E-D8F8-427F-B5AB-0AAAABA027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38E8D-025B-4181-BCDB-CDF68F86EB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FCF5F-CC56-4DEA-85BA-8A2B9F2205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6FB45-EA97-42FD-AEC8-853C648A13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76FA4-0899-4487-9362-E01BECD347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1943E-77AF-486A-85E9-71A727CA5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  <a:ea typeface="新細明體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E2CD24-07B3-47D7-880B-1799C72A5985}" type="slidenum">
              <a:rPr b="0" lang="zh-TW" sz="1400" spc="-1" strike="noStrike">
                <a:solidFill>
                  <a:srgbClr val="000000"/>
                </a:solidFill>
                <a:latin typeface="Arial"/>
                <a:ea typeface="新細明體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65200" y="1116000"/>
          <a:ext cx="4176720" cy="2117880"/>
        </p:xfrm>
        <a:graphic>
          <a:graphicData uri="http://schemas.openxmlformats.org/drawingml/2006/table">
            <a:tbl>
              <a:tblPr/>
              <a:tblGrid>
                <a:gridCol w="1173240"/>
                <a:gridCol w="1458720"/>
                <a:gridCol w="1544760"/>
              </a:tblGrid>
              <a:tr h="29160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ChI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LMP1 promo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82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(% of inpu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ATP deple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(% of inpu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I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0. 54 ± 0.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0.51 ± 0.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9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PE2(EBNA2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.44 ± 0.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0.22 ± 0.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RBP-Jκ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.83 ± 1.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.28 ± 2.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NPM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5.45 ± 1.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0.57 ± 0.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484280" y="3995640"/>
          <a:ext cx="4176720" cy="1482480"/>
        </p:xfrm>
        <a:graphic>
          <a:graphicData uri="http://schemas.openxmlformats.org/drawingml/2006/table">
            <a:tbl>
              <a:tblPr/>
              <a:tblGrid>
                <a:gridCol w="1173240"/>
                <a:gridCol w="1459080"/>
                <a:gridCol w="1544400"/>
              </a:tblGrid>
              <a:tr h="26676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ChI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GAPDH promo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82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(% of inpu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ATP deple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(% of inpu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I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.16 ±  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1.21 ± 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H3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4.31 ±  0.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4.38 ± 0.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"/>
          <p:cNvSpPr/>
          <p:nvPr/>
        </p:nvSpPr>
        <p:spPr>
          <a:xfrm>
            <a:off x="-45000" y="158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31680" y="6112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931680" y="35686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64600" y="668160"/>
            <a:ext cx="197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ATP depletion (IB4 cell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54880" y="3625920"/>
            <a:ext cx="197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ATP depletion (IB4 cell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1455840" y="6392880"/>
          <a:ext cx="4321080" cy="1492200"/>
        </p:xfrm>
        <a:graphic>
          <a:graphicData uri="http://schemas.openxmlformats.org/drawingml/2006/table">
            <a:tbl>
              <a:tblPr/>
              <a:tblGrid>
                <a:gridCol w="1020600"/>
                <a:gridCol w="330048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Promo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Primers for real time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97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LMP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Forward: 5’-GTACGGGTACAGATTTCC-3’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Reverse: 5’-CTGCCGCCAACGACCTC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GAPD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Forward: 5’-TACTAGCGGTTTTACGGGCG-3.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Reverse: 5’-TCGAACAGGAGGAGCAGAGA  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                 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新細明體"/>
                        </a:rPr>
                        <a:t>GCGA-3’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"/>
          <p:cNvSpPr/>
          <p:nvPr/>
        </p:nvSpPr>
        <p:spPr>
          <a:xfrm>
            <a:off x="982440" y="60120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2205000" y="1450800"/>
          <a:ext cx="2009880" cy="15526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05000" y="1450800"/>
                    <a:ext cx="2009880" cy="1552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"/>
          <p:cNvSpPr/>
          <p:nvPr/>
        </p:nvSpPr>
        <p:spPr>
          <a:xfrm>
            <a:off x="-45000" y="158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新細明體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2847960" y="3147840"/>
          <a:ext cx="1204920" cy="167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847960" y="3147840"/>
                    <a:ext cx="1204920" cy="167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5" name=""/>
          <p:cNvSpPr/>
          <p:nvPr/>
        </p:nvSpPr>
        <p:spPr>
          <a:xfrm>
            <a:off x="2998440" y="247968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802240" y="25081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136240" y="2719440"/>
            <a:ext cx="76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CMV-βg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209760" y="247968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427200" y="247968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196360" y="2536920"/>
            <a:ext cx="70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SV40-Lu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638160" y="248436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835080" y="247968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962520" y="3051000"/>
            <a:ext cx="7696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Act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998440" y="265752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792520" y="270504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209760" y="265752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427200" y="265752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638160" y="266220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835080" y="2657520"/>
            <a:ext cx="2494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  <a:ea typeface="新細明體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288520" y="2906640"/>
            <a:ext cx="56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ATP(-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h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176280" y="29257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373200" y="29257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589200" y="29210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771720" y="29257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新細明體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811600" y="289548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027600" y="289080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141920" y="669960"/>
            <a:ext cx="176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ATP depletion (BJA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96240" y="1488960"/>
            <a:ext cx="70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 u="sng">
                <a:solidFill>
                  <a:srgbClr val="000000"/>
                </a:solidFill>
                <a:uFillTx/>
                <a:latin typeface="Arial"/>
                <a:ea typeface="新細明體"/>
              </a:rPr>
              <a:t>SV40-Lu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932040" y="61128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D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0" name=""/>
          <p:cNvGraphicFramePr/>
          <p:nvPr/>
        </p:nvGraphicFramePr>
        <p:xfrm>
          <a:off x="2630520" y="4802040"/>
          <a:ext cx="1152360" cy="2336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1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630520" y="4802040"/>
                    <a:ext cx="1152360" cy="233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2" name=""/>
          <p:cNvGraphicFramePr/>
          <p:nvPr/>
        </p:nvGraphicFramePr>
        <p:xfrm>
          <a:off x="2630520" y="4559400"/>
          <a:ext cx="1152360" cy="2109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83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630520" y="4559400"/>
                    <a:ext cx="1152360" cy="210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4" name=""/>
          <p:cNvGraphicFramePr/>
          <p:nvPr/>
        </p:nvGraphicFramePr>
        <p:xfrm>
          <a:off x="2630520" y="5079960"/>
          <a:ext cx="1152360" cy="2286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85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630520" y="5079960"/>
                    <a:ext cx="1152360" cy="228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6" name=""/>
          <p:cNvSpPr/>
          <p:nvPr/>
        </p:nvSpPr>
        <p:spPr>
          <a:xfrm>
            <a:off x="3677040" y="5234040"/>
            <a:ext cx="73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(5% input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675600" y="4762440"/>
            <a:ext cx="76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FNPM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(5% input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678120" y="5079960"/>
            <a:ext cx="44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686400" y="4546440"/>
            <a:ext cx="59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FNPM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795400" y="4375080"/>
            <a:ext cx="35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W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8900000">
            <a:off x="3036600" y="429228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L102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8900000">
            <a:off x="3240360" y="4308120"/>
            <a:ext cx="543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G105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8900000">
            <a:off x="3492720" y="4296960"/>
            <a:ext cx="531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S106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535480" y="4371840"/>
            <a:ext cx="41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新細明體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5" name=""/>
          <p:cNvGraphicFramePr/>
          <p:nvPr/>
        </p:nvGraphicFramePr>
        <p:xfrm>
          <a:off x="2630520" y="5343480"/>
          <a:ext cx="1152360" cy="1857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96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630520" y="5343480"/>
                    <a:ext cx="1152360" cy="185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7" name=""/>
          <p:cNvSpPr/>
          <p:nvPr/>
        </p:nvSpPr>
        <p:spPr>
          <a:xfrm>
            <a:off x="1153080" y="3800520"/>
            <a:ext cx="183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新細明體"/>
              </a:rPr>
              <a:t>ATP-agarose pulld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936720" y="3745080"/>
            <a:ext cx="37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新細明體"/>
              </a:rPr>
              <a:t>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3T07:43:06Z</dcterms:created>
  <dc:creator>User</dc:creator>
  <dc:description/>
  <dc:language>en-US</dc:language>
  <cp:lastModifiedBy>MC SYSTEM</cp:lastModifiedBy>
  <dcterms:modified xsi:type="dcterms:W3CDTF">2012-09-11T12:22:51Z</dcterms:modified>
  <cp:revision>1643</cp:revision>
  <dc:subject/>
  <dc:title>投影片 1</dc:title>
</cp:coreProperties>
</file>